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50C6899-DD55-4D7E-BD96-C4C35035E7EB}" v="15" dt="2021-10-11T00:07:34.5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97" autoAdjust="0"/>
  </p:normalViewPr>
  <p:slideViewPr>
    <p:cSldViewPr>
      <p:cViewPr varScale="1">
        <p:scale>
          <a:sx n="71" d="100"/>
          <a:sy n="71" d="100"/>
        </p:scale>
        <p:origin x="618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353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522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429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546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774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533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59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7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3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174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FA9A3-2356-4393-9D4E-57C1AC915566}" type="datetimeFigureOut">
              <a:rPr lang="en-US" smtClean="0"/>
              <a:t>8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8DFA5-7A50-4DC1-9734-EB9E162135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2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607">
            <a:extLst>
              <a:ext uri="{FF2B5EF4-FFF2-40B4-BE49-F238E27FC236}">
                <a16:creationId xmlns:a16="http://schemas.microsoft.com/office/drawing/2014/main" id="{9B577C44-D6F9-4D7C-BB80-4DBE8A471F51}"/>
              </a:ext>
            </a:extLst>
          </p:cNvPr>
          <p:cNvGrpSpPr>
            <a:grpSpLocks/>
          </p:cNvGrpSpPr>
          <p:nvPr/>
        </p:nvGrpSpPr>
        <p:grpSpPr bwMode="auto">
          <a:xfrm>
            <a:off x="-304800" y="2514600"/>
            <a:ext cx="9207500" cy="3397251"/>
            <a:chOff x="-135" y="1905"/>
            <a:chExt cx="5800" cy="2140"/>
          </a:xfrm>
        </p:grpSpPr>
        <p:sp>
          <p:nvSpPr>
            <p:cNvPr id="1129" name="Freeform 434">
              <a:extLst>
                <a:ext uri="{FF2B5EF4-FFF2-40B4-BE49-F238E27FC236}">
                  <a16:creationId xmlns:a16="http://schemas.microsoft.com/office/drawing/2014/main" id="{81D1CA01-A48E-4729-AEA4-7F60BA1A72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63" y="2032"/>
              <a:ext cx="1774" cy="91"/>
            </a:xfrm>
            <a:custGeom>
              <a:avLst/>
              <a:gdLst>
                <a:gd name="T0" fmla="*/ 0 w 506"/>
                <a:gd name="T1" fmla="*/ 26 h 26"/>
                <a:gd name="T2" fmla="*/ 7 w 506"/>
                <a:gd name="T3" fmla="*/ 25 h 26"/>
                <a:gd name="T4" fmla="*/ 15 w 506"/>
                <a:gd name="T5" fmla="*/ 19 h 26"/>
                <a:gd name="T6" fmla="*/ 146 w 506"/>
                <a:gd name="T7" fmla="*/ 10 h 26"/>
                <a:gd name="T8" fmla="*/ 506 w 506"/>
                <a:gd name="T9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/>
            </a:custGeom>
            <a:solidFill>
              <a:srgbClr val="C0C0C0"/>
            </a:solidFill>
            <a:ln w="0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0" name="Freeform 435">
              <a:extLst>
                <a:ext uri="{FF2B5EF4-FFF2-40B4-BE49-F238E27FC236}">
                  <a16:creationId xmlns:a16="http://schemas.microsoft.com/office/drawing/2014/main" id="{E37C3BA8-5DAF-4B5C-BB98-5302A435D7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6" y="1986"/>
              <a:ext cx="617" cy="137"/>
            </a:xfrm>
            <a:custGeom>
              <a:avLst/>
              <a:gdLst>
                <a:gd name="T0" fmla="*/ 0 w 176"/>
                <a:gd name="T1" fmla="*/ 39 h 39"/>
                <a:gd name="T2" fmla="*/ 8 w 176"/>
                <a:gd name="T3" fmla="*/ 38 h 39"/>
                <a:gd name="T4" fmla="*/ 16 w 176"/>
                <a:gd name="T5" fmla="*/ 35 h 39"/>
                <a:gd name="T6" fmla="*/ 24 w 176"/>
                <a:gd name="T7" fmla="*/ 29 h 39"/>
                <a:gd name="T8" fmla="*/ 28 w 176"/>
                <a:gd name="T9" fmla="*/ 20 h 39"/>
                <a:gd name="T10" fmla="*/ 32 w 176"/>
                <a:gd name="T11" fmla="*/ 11 h 39"/>
                <a:gd name="T12" fmla="*/ 36 w 176"/>
                <a:gd name="T13" fmla="*/ 4 h 39"/>
                <a:gd name="T14" fmla="*/ 41 w 176"/>
                <a:gd name="T15" fmla="*/ 0 h 39"/>
                <a:gd name="T16" fmla="*/ 45 w 176"/>
                <a:gd name="T17" fmla="*/ 2 h 39"/>
                <a:gd name="T18" fmla="*/ 49 w 176"/>
                <a:gd name="T19" fmla="*/ 8 h 39"/>
                <a:gd name="T20" fmla="*/ 53 w 176"/>
                <a:gd name="T21" fmla="*/ 17 h 39"/>
                <a:gd name="T22" fmla="*/ 56 w 176"/>
                <a:gd name="T23" fmla="*/ 26 h 39"/>
                <a:gd name="T24" fmla="*/ 65 w 176"/>
                <a:gd name="T25" fmla="*/ 33 h 39"/>
                <a:gd name="T26" fmla="*/ 74 w 176"/>
                <a:gd name="T27" fmla="*/ 38 h 39"/>
                <a:gd name="T28" fmla="*/ 176 w 176"/>
                <a:gd name="T29" fmla="*/ 39 h 39"/>
                <a:gd name="T30" fmla="*/ 176 w 176"/>
                <a:gd name="T31" fmla="*/ 3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/>
            </a:custGeom>
            <a:solidFill>
              <a:srgbClr val="C0C0C0"/>
            </a:solidFill>
            <a:ln w="0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1" name="Freeform 436">
              <a:extLst>
                <a:ext uri="{FF2B5EF4-FFF2-40B4-BE49-F238E27FC236}">
                  <a16:creationId xmlns:a16="http://schemas.microsoft.com/office/drawing/2014/main" id="{99CCB3C6-6B1F-4670-9716-EAC1A55774C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135" y="1905"/>
              <a:ext cx="3381" cy="218"/>
            </a:xfrm>
            <a:custGeom>
              <a:avLst/>
              <a:gdLst>
                <a:gd name="T0" fmla="*/ 0 w 964"/>
                <a:gd name="T1" fmla="*/ 59 h 62"/>
                <a:gd name="T2" fmla="*/ 37 w 964"/>
                <a:gd name="T3" fmla="*/ 38 h 62"/>
                <a:gd name="T4" fmla="*/ 677 w 964"/>
                <a:gd name="T5" fmla="*/ 15 h 62"/>
                <a:gd name="T6" fmla="*/ 685 w 964"/>
                <a:gd name="T7" fmla="*/ 0 h 62"/>
                <a:gd name="T8" fmla="*/ 692 w 964"/>
                <a:gd name="T9" fmla="*/ 0 h 62"/>
                <a:gd name="T10" fmla="*/ 700 w 964"/>
                <a:gd name="T11" fmla="*/ 12 h 62"/>
                <a:gd name="T12" fmla="*/ 708 w 964"/>
                <a:gd name="T13" fmla="*/ 27 h 62"/>
                <a:gd name="T14" fmla="*/ 716 w 964"/>
                <a:gd name="T15" fmla="*/ 39 h 62"/>
                <a:gd name="T16" fmla="*/ 723 w 964"/>
                <a:gd name="T17" fmla="*/ 46 h 62"/>
                <a:gd name="T18" fmla="*/ 731 w 964"/>
                <a:gd name="T19" fmla="*/ 51 h 62"/>
                <a:gd name="T20" fmla="*/ 739 w 964"/>
                <a:gd name="T21" fmla="*/ 55 h 62"/>
                <a:gd name="T22" fmla="*/ 747 w 964"/>
                <a:gd name="T23" fmla="*/ 59 h 62"/>
                <a:gd name="T24" fmla="*/ 753 w 964"/>
                <a:gd name="T25" fmla="*/ 61 h 62"/>
                <a:gd name="T26" fmla="*/ 964 w 964"/>
                <a:gd name="T27" fmla="*/ 62 h 62"/>
                <a:gd name="T28" fmla="*/ 964 w 964"/>
                <a:gd name="T29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964" h="62">
                  <a:moveTo>
                    <a:pt x="964" y="62"/>
                  </a:moveTo>
                  <a:lnTo>
                    <a:pt x="964" y="62"/>
                  </a:lnTo>
                </a:path>
              </a:pathLst>
            </a:custGeom>
            <a:solidFill>
              <a:srgbClr val="C0C0C0"/>
            </a:solidFill>
            <a:ln w="0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4" name="Rectangle 469">
              <a:extLst>
                <a:ext uri="{FF2B5EF4-FFF2-40B4-BE49-F238E27FC236}">
                  <a16:creationId xmlns:a16="http://schemas.microsoft.com/office/drawing/2014/main" id="{97A11B3D-F965-4724-B88E-DEC019A15E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1" y="2351"/>
              <a:ext cx="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75" name="Line 480">
              <a:extLst>
                <a:ext uri="{FF2B5EF4-FFF2-40B4-BE49-F238E27FC236}">
                  <a16:creationId xmlns:a16="http://schemas.microsoft.com/office/drawing/2014/main" id="{73BE8E0D-10A0-43BD-B794-72FA96D4D6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" y="3596"/>
              <a:ext cx="509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6" name="Line 481">
              <a:extLst>
                <a:ext uri="{FF2B5EF4-FFF2-40B4-BE49-F238E27FC236}">
                  <a16:creationId xmlns:a16="http://schemas.microsoft.com/office/drawing/2014/main" id="{DECFEDD4-341D-4F34-804A-DDC7B26792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7" name="Line 482">
              <a:extLst>
                <a:ext uri="{FF2B5EF4-FFF2-40B4-BE49-F238E27FC236}">
                  <a16:creationId xmlns:a16="http://schemas.microsoft.com/office/drawing/2014/main" id="{A9C49773-F6D8-4FE8-BE40-CA8054DAAB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8" name="Line 483">
              <a:extLst>
                <a:ext uri="{FF2B5EF4-FFF2-40B4-BE49-F238E27FC236}">
                  <a16:creationId xmlns:a16="http://schemas.microsoft.com/office/drawing/2014/main" id="{5A70CD09-C0CE-4C17-B589-E75B988D72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9" name="Line 484">
              <a:extLst>
                <a:ext uri="{FF2B5EF4-FFF2-40B4-BE49-F238E27FC236}">
                  <a16:creationId xmlns:a16="http://schemas.microsoft.com/office/drawing/2014/main" id="{18B71FBA-A7FB-4CB9-8C18-F50A6A59BF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0" name="Line 485">
              <a:extLst>
                <a:ext uri="{FF2B5EF4-FFF2-40B4-BE49-F238E27FC236}">
                  <a16:creationId xmlns:a16="http://schemas.microsoft.com/office/drawing/2014/main" id="{D4AD5CF7-198D-4F36-9A00-BEDDA6E421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1" name="Line 486">
              <a:extLst>
                <a:ext uri="{FF2B5EF4-FFF2-40B4-BE49-F238E27FC236}">
                  <a16:creationId xmlns:a16="http://schemas.microsoft.com/office/drawing/2014/main" id="{65CC8BA6-7C59-4AF6-A142-A1EFAF1A32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2" name="Line 487">
              <a:extLst>
                <a:ext uri="{FF2B5EF4-FFF2-40B4-BE49-F238E27FC236}">
                  <a16:creationId xmlns:a16="http://schemas.microsoft.com/office/drawing/2014/main" id="{8640F7ED-ABA3-4AB0-AE88-3149A11C23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3" name="Line 488">
              <a:extLst>
                <a:ext uri="{FF2B5EF4-FFF2-40B4-BE49-F238E27FC236}">
                  <a16:creationId xmlns:a16="http://schemas.microsoft.com/office/drawing/2014/main" id="{816B5EA0-1228-41BF-89C3-D20C80C6B2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4" name="Line 489">
              <a:extLst>
                <a:ext uri="{FF2B5EF4-FFF2-40B4-BE49-F238E27FC236}">
                  <a16:creationId xmlns:a16="http://schemas.microsoft.com/office/drawing/2014/main" id="{56EEDBFC-F401-440A-9655-EA50C423B8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0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5" name="Line 490">
              <a:extLst>
                <a:ext uri="{FF2B5EF4-FFF2-40B4-BE49-F238E27FC236}">
                  <a16:creationId xmlns:a16="http://schemas.microsoft.com/office/drawing/2014/main" id="{A1DEE247-D051-434F-A0BC-E650BA31C1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6" name="Line 491">
              <a:extLst>
                <a:ext uri="{FF2B5EF4-FFF2-40B4-BE49-F238E27FC236}">
                  <a16:creationId xmlns:a16="http://schemas.microsoft.com/office/drawing/2014/main" id="{C25AF65A-C5ED-4499-92D7-4AE65086D0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7" name="Line 492">
              <a:extLst>
                <a:ext uri="{FF2B5EF4-FFF2-40B4-BE49-F238E27FC236}">
                  <a16:creationId xmlns:a16="http://schemas.microsoft.com/office/drawing/2014/main" id="{DB0E1297-A8E3-4DC1-9EC7-BB6B9A3645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8" name="Line 493">
              <a:extLst>
                <a:ext uri="{FF2B5EF4-FFF2-40B4-BE49-F238E27FC236}">
                  <a16:creationId xmlns:a16="http://schemas.microsoft.com/office/drawing/2014/main" id="{6F635387-2A0A-4ADE-A76A-F4A2750CFE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9" name="Line 494">
              <a:extLst>
                <a:ext uri="{FF2B5EF4-FFF2-40B4-BE49-F238E27FC236}">
                  <a16:creationId xmlns:a16="http://schemas.microsoft.com/office/drawing/2014/main" id="{8A0C3373-83D7-4492-A7B8-90906DB966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7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0" name="Line 495">
              <a:extLst>
                <a:ext uri="{FF2B5EF4-FFF2-40B4-BE49-F238E27FC236}">
                  <a16:creationId xmlns:a16="http://schemas.microsoft.com/office/drawing/2014/main" id="{3804D23E-D96D-4A99-AE48-7AF59C11D0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1" name="Line 496">
              <a:extLst>
                <a:ext uri="{FF2B5EF4-FFF2-40B4-BE49-F238E27FC236}">
                  <a16:creationId xmlns:a16="http://schemas.microsoft.com/office/drawing/2014/main" id="{FB18321B-27C7-4488-90C6-C1EE8777BA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2" name="Line 497">
              <a:extLst>
                <a:ext uri="{FF2B5EF4-FFF2-40B4-BE49-F238E27FC236}">
                  <a16:creationId xmlns:a16="http://schemas.microsoft.com/office/drawing/2014/main" id="{1B9755AB-881E-4A91-B0C5-82019F62F7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3" name="Line 498">
              <a:extLst>
                <a:ext uri="{FF2B5EF4-FFF2-40B4-BE49-F238E27FC236}">
                  <a16:creationId xmlns:a16="http://schemas.microsoft.com/office/drawing/2014/main" id="{9FF028E0-1B05-49ED-B05F-E663655B4B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4" name="Line 499">
              <a:extLst>
                <a:ext uri="{FF2B5EF4-FFF2-40B4-BE49-F238E27FC236}">
                  <a16:creationId xmlns:a16="http://schemas.microsoft.com/office/drawing/2014/main" id="{CE9F1E44-E340-43EA-9A57-CD6F17AC33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5" name="Line 500">
              <a:extLst>
                <a:ext uri="{FF2B5EF4-FFF2-40B4-BE49-F238E27FC236}">
                  <a16:creationId xmlns:a16="http://schemas.microsoft.com/office/drawing/2014/main" id="{3E3D76D3-F936-4901-B1E4-9AD7FE15B3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6" name="Line 501">
              <a:extLst>
                <a:ext uri="{FF2B5EF4-FFF2-40B4-BE49-F238E27FC236}">
                  <a16:creationId xmlns:a16="http://schemas.microsoft.com/office/drawing/2014/main" id="{84F36AA9-F5D6-446C-8052-367652DA00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7" name="Line 502">
              <a:extLst>
                <a:ext uri="{FF2B5EF4-FFF2-40B4-BE49-F238E27FC236}">
                  <a16:creationId xmlns:a16="http://schemas.microsoft.com/office/drawing/2014/main" id="{7FC8E1E5-8862-4587-A672-E845B9A692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8" name="Line 503">
              <a:extLst>
                <a:ext uri="{FF2B5EF4-FFF2-40B4-BE49-F238E27FC236}">
                  <a16:creationId xmlns:a16="http://schemas.microsoft.com/office/drawing/2014/main" id="{2C0C3CFC-164C-4628-956C-50E09002CA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9" name="Line 504">
              <a:extLst>
                <a:ext uri="{FF2B5EF4-FFF2-40B4-BE49-F238E27FC236}">
                  <a16:creationId xmlns:a16="http://schemas.microsoft.com/office/drawing/2014/main" id="{BC1153AD-1E8D-4CD1-BF5E-7AD9C0F090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0" name="Line 505">
              <a:extLst>
                <a:ext uri="{FF2B5EF4-FFF2-40B4-BE49-F238E27FC236}">
                  <a16:creationId xmlns:a16="http://schemas.microsoft.com/office/drawing/2014/main" id="{FCB93DA3-2792-4660-AE6A-DF0C65AE9D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3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1" name="Line 506">
              <a:extLst>
                <a:ext uri="{FF2B5EF4-FFF2-40B4-BE49-F238E27FC236}">
                  <a16:creationId xmlns:a16="http://schemas.microsoft.com/office/drawing/2014/main" id="{F51300EC-1C7B-4BA1-A5D9-A2793CE11A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2" name="Line 507">
              <a:extLst>
                <a:ext uri="{FF2B5EF4-FFF2-40B4-BE49-F238E27FC236}">
                  <a16:creationId xmlns:a16="http://schemas.microsoft.com/office/drawing/2014/main" id="{5CF7F98F-8E93-4E9C-ABF1-88B51465C0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3" name="Line 508">
              <a:extLst>
                <a:ext uri="{FF2B5EF4-FFF2-40B4-BE49-F238E27FC236}">
                  <a16:creationId xmlns:a16="http://schemas.microsoft.com/office/drawing/2014/main" id="{FBDAA7B7-6F01-4972-A43D-112B32CF17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4" name="Line 509">
              <a:extLst>
                <a:ext uri="{FF2B5EF4-FFF2-40B4-BE49-F238E27FC236}">
                  <a16:creationId xmlns:a16="http://schemas.microsoft.com/office/drawing/2014/main" id="{36E0F98B-4360-406C-9BE8-3203CC248D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5" name="Line 510">
              <a:extLst>
                <a:ext uri="{FF2B5EF4-FFF2-40B4-BE49-F238E27FC236}">
                  <a16:creationId xmlns:a16="http://schemas.microsoft.com/office/drawing/2014/main" id="{6BFE9B4E-E070-43F7-B036-53746970D1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6" name="Line 511">
              <a:extLst>
                <a:ext uri="{FF2B5EF4-FFF2-40B4-BE49-F238E27FC236}">
                  <a16:creationId xmlns:a16="http://schemas.microsoft.com/office/drawing/2014/main" id="{537F01A3-264C-4C97-BCCE-C7BC7E1DAC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7" name="Line 512">
              <a:extLst>
                <a:ext uri="{FF2B5EF4-FFF2-40B4-BE49-F238E27FC236}">
                  <a16:creationId xmlns:a16="http://schemas.microsoft.com/office/drawing/2014/main" id="{1F5303DE-7631-43C4-9367-6F65FF0E03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8" name="Line 513">
              <a:extLst>
                <a:ext uri="{FF2B5EF4-FFF2-40B4-BE49-F238E27FC236}">
                  <a16:creationId xmlns:a16="http://schemas.microsoft.com/office/drawing/2014/main" id="{ABD0C180-CEAF-40A1-A6FA-95AFAE9023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9" name="Line 514">
              <a:extLst>
                <a:ext uri="{FF2B5EF4-FFF2-40B4-BE49-F238E27FC236}">
                  <a16:creationId xmlns:a16="http://schemas.microsoft.com/office/drawing/2014/main" id="{730FBA25-FCE6-4172-82D0-6128B105F2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0" name="Line 515">
              <a:extLst>
                <a:ext uri="{FF2B5EF4-FFF2-40B4-BE49-F238E27FC236}">
                  <a16:creationId xmlns:a16="http://schemas.microsoft.com/office/drawing/2014/main" id="{07122D49-95DE-4119-9396-A8546457E9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5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1" name="Line 516">
              <a:extLst>
                <a:ext uri="{FF2B5EF4-FFF2-40B4-BE49-F238E27FC236}">
                  <a16:creationId xmlns:a16="http://schemas.microsoft.com/office/drawing/2014/main" id="{28E855F0-A080-4B6F-9F43-49130908CC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1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2" name="Line 517">
              <a:extLst>
                <a:ext uri="{FF2B5EF4-FFF2-40B4-BE49-F238E27FC236}">
                  <a16:creationId xmlns:a16="http://schemas.microsoft.com/office/drawing/2014/main" id="{C9A8BFDC-E8C2-48FD-9085-BEFF7D410D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3" name="Line 518">
              <a:extLst>
                <a:ext uri="{FF2B5EF4-FFF2-40B4-BE49-F238E27FC236}">
                  <a16:creationId xmlns:a16="http://schemas.microsoft.com/office/drawing/2014/main" id="{55CDAA73-FDD8-4C28-B932-EB4AE4179C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4" name="Line 519">
              <a:extLst>
                <a:ext uri="{FF2B5EF4-FFF2-40B4-BE49-F238E27FC236}">
                  <a16:creationId xmlns:a16="http://schemas.microsoft.com/office/drawing/2014/main" id="{044DEB40-93F0-4944-84A9-093530DFED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5" name="Line 520">
              <a:extLst>
                <a:ext uri="{FF2B5EF4-FFF2-40B4-BE49-F238E27FC236}">
                  <a16:creationId xmlns:a16="http://schemas.microsoft.com/office/drawing/2014/main" id="{008E7BA7-ED0F-427C-9C02-7749E4D446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6" name="Line 521">
              <a:extLst>
                <a:ext uri="{FF2B5EF4-FFF2-40B4-BE49-F238E27FC236}">
                  <a16:creationId xmlns:a16="http://schemas.microsoft.com/office/drawing/2014/main" id="{CAA7DA79-2CD9-44A3-97CF-D7FA287A8B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7" name="Line 522">
              <a:extLst>
                <a:ext uri="{FF2B5EF4-FFF2-40B4-BE49-F238E27FC236}">
                  <a16:creationId xmlns:a16="http://schemas.microsoft.com/office/drawing/2014/main" id="{9868675F-7F43-45A1-A95B-B317B18517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56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8" name="Line 523">
              <a:extLst>
                <a:ext uri="{FF2B5EF4-FFF2-40B4-BE49-F238E27FC236}">
                  <a16:creationId xmlns:a16="http://schemas.microsoft.com/office/drawing/2014/main" id="{282626AE-2B07-44C4-B813-AB0EA5C45B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9" name="Line 524">
              <a:extLst>
                <a:ext uri="{FF2B5EF4-FFF2-40B4-BE49-F238E27FC236}">
                  <a16:creationId xmlns:a16="http://schemas.microsoft.com/office/drawing/2014/main" id="{F8477371-E76D-4F3D-9D10-9AB7F8485F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0" name="Line 525">
              <a:extLst>
                <a:ext uri="{FF2B5EF4-FFF2-40B4-BE49-F238E27FC236}">
                  <a16:creationId xmlns:a16="http://schemas.microsoft.com/office/drawing/2014/main" id="{F4F1BC3E-5F64-44FC-89AD-D135DE02C2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1" name="Line 526">
              <a:extLst>
                <a:ext uri="{FF2B5EF4-FFF2-40B4-BE49-F238E27FC236}">
                  <a16:creationId xmlns:a16="http://schemas.microsoft.com/office/drawing/2014/main" id="{A6A45E6D-7CB6-4B51-8977-B2EDD46984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8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2" name="Line 527">
              <a:extLst>
                <a:ext uri="{FF2B5EF4-FFF2-40B4-BE49-F238E27FC236}">
                  <a16:creationId xmlns:a16="http://schemas.microsoft.com/office/drawing/2014/main" id="{E360C2DE-C6E9-4CC2-9064-F2A8045840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2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3" name="Line 528">
              <a:extLst>
                <a:ext uri="{FF2B5EF4-FFF2-40B4-BE49-F238E27FC236}">
                  <a16:creationId xmlns:a16="http://schemas.microsoft.com/office/drawing/2014/main" id="{AA1B5B91-F924-4F6A-952F-8B999E5653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4" name="Line 529">
              <a:extLst>
                <a:ext uri="{FF2B5EF4-FFF2-40B4-BE49-F238E27FC236}">
                  <a16:creationId xmlns:a16="http://schemas.microsoft.com/office/drawing/2014/main" id="{6E887D28-1055-4CBE-B353-120BE86EA0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5" name="Line 530">
              <a:extLst>
                <a:ext uri="{FF2B5EF4-FFF2-40B4-BE49-F238E27FC236}">
                  <a16:creationId xmlns:a16="http://schemas.microsoft.com/office/drawing/2014/main" id="{78E9BEA3-D6D5-4925-ADE7-1404F3E177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6" name="Line 531">
              <a:extLst>
                <a:ext uri="{FF2B5EF4-FFF2-40B4-BE49-F238E27FC236}">
                  <a16:creationId xmlns:a16="http://schemas.microsoft.com/office/drawing/2014/main" id="{155AEADE-D72C-4DBB-B398-189CF2AE31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7" name="Line 532">
              <a:extLst>
                <a:ext uri="{FF2B5EF4-FFF2-40B4-BE49-F238E27FC236}">
                  <a16:creationId xmlns:a16="http://schemas.microsoft.com/office/drawing/2014/main" id="{838680C6-2682-47B2-8888-3F719A4453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8" name="Line 533">
              <a:extLst>
                <a:ext uri="{FF2B5EF4-FFF2-40B4-BE49-F238E27FC236}">
                  <a16:creationId xmlns:a16="http://schemas.microsoft.com/office/drawing/2014/main" id="{4A5C9522-912A-4679-9AE2-11BA058376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62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9" name="Line 534">
              <a:extLst>
                <a:ext uri="{FF2B5EF4-FFF2-40B4-BE49-F238E27FC236}">
                  <a16:creationId xmlns:a16="http://schemas.microsoft.com/office/drawing/2014/main" id="{BE884B26-92F1-4810-9574-70118FA8F7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2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0" name="Line 535">
              <a:extLst>
                <a:ext uri="{FF2B5EF4-FFF2-40B4-BE49-F238E27FC236}">
                  <a16:creationId xmlns:a16="http://schemas.microsoft.com/office/drawing/2014/main" id="{C5A724D8-CB51-4B07-A562-0E3770F43A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1" name="Line 536">
              <a:extLst>
                <a:ext uri="{FF2B5EF4-FFF2-40B4-BE49-F238E27FC236}">
                  <a16:creationId xmlns:a16="http://schemas.microsoft.com/office/drawing/2014/main" id="{B96251D1-23B3-4545-8012-B2D226CF8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29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2" name="Line 537">
              <a:extLst>
                <a:ext uri="{FF2B5EF4-FFF2-40B4-BE49-F238E27FC236}">
                  <a16:creationId xmlns:a16="http://schemas.microsoft.com/office/drawing/2014/main" id="{12745C88-94C1-4027-84CC-6FF3D4FF2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9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3" name="Line 538">
              <a:extLst>
                <a:ext uri="{FF2B5EF4-FFF2-40B4-BE49-F238E27FC236}">
                  <a16:creationId xmlns:a16="http://schemas.microsoft.com/office/drawing/2014/main" id="{02F0F70D-2D02-455B-AB5F-A9DE3EC759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5" y="3596"/>
              <a:ext cx="0" cy="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4" name="Line 539">
              <a:extLst>
                <a:ext uri="{FF2B5EF4-FFF2-40B4-BE49-F238E27FC236}">
                  <a16:creationId xmlns:a16="http://schemas.microsoft.com/office/drawing/2014/main" id="{5805717E-2DD2-4C8E-9891-D6431FCA44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5" name="Rectangle 540">
              <a:extLst>
                <a:ext uri="{FF2B5EF4-FFF2-40B4-BE49-F238E27FC236}">
                  <a16:creationId xmlns:a16="http://schemas.microsoft.com/office/drawing/2014/main" id="{5127E941-FAC0-41EA-8943-57E29D9F54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" y="3627"/>
              <a:ext cx="10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6" name="Line 541">
              <a:extLst>
                <a:ext uri="{FF2B5EF4-FFF2-40B4-BE49-F238E27FC236}">
                  <a16:creationId xmlns:a16="http://schemas.microsoft.com/office/drawing/2014/main" id="{3B8150B7-193F-4D10-A3AB-0015AEA033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0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7" name="Rectangle 542">
              <a:extLst>
                <a:ext uri="{FF2B5EF4-FFF2-40B4-BE49-F238E27FC236}">
                  <a16:creationId xmlns:a16="http://schemas.microsoft.com/office/drawing/2014/main" id="{2A39C4F6-96EB-4614-A71E-36A14DE12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3" y="3627"/>
              <a:ext cx="10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8" name="Line 543">
              <a:extLst>
                <a:ext uri="{FF2B5EF4-FFF2-40B4-BE49-F238E27FC236}">
                  <a16:creationId xmlns:a16="http://schemas.microsoft.com/office/drawing/2014/main" id="{34D73B67-9336-4FB2-A853-4B393648B7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0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9" name="Rectangle 544">
              <a:extLst>
                <a:ext uri="{FF2B5EF4-FFF2-40B4-BE49-F238E27FC236}">
                  <a16:creationId xmlns:a16="http://schemas.microsoft.com/office/drawing/2014/main" id="{3DF8D626-D438-4741-86D8-FC780A0F47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9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0" name="Line 545">
              <a:extLst>
                <a:ext uri="{FF2B5EF4-FFF2-40B4-BE49-F238E27FC236}">
                  <a16:creationId xmlns:a16="http://schemas.microsoft.com/office/drawing/2014/main" id="{05236AAE-05B6-4D57-AABE-C528E4C3B6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36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1" name="Rectangle 546">
              <a:extLst>
                <a:ext uri="{FF2B5EF4-FFF2-40B4-BE49-F238E27FC236}">
                  <a16:creationId xmlns:a16="http://schemas.microsoft.com/office/drawing/2014/main" id="{31EF5D09-F0DA-40F4-9A45-68B3BF495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5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2" name="Line 547">
              <a:extLst>
                <a:ext uri="{FF2B5EF4-FFF2-40B4-BE49-F238E27FC236}">
                  <a16:creationId xmlns:a16="http://schemas.microsoft.com/office/drawing/2014/main" id="{073C0141-E81B-4FA9-9B30-B41E73515C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6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3" name="Rectangle 548">
              <a:extLst>
                <a:ext uri="{FF2B5EF4-FFF2-40B4-BE49-F238E27FC236}">
                  <a16:creationId xmlns:a16="http://schemas.microsoft.com/office/drawing/2014/main" id="{B2902F6F-A778-4279-BFF1-4EAA01A03D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5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4" name="Line 549">
              <a:extLst>
                <a:ext uri="{FF2B5EF4-FFF2-40B4-BE49-F238E27FC236}">
                  <a16:creationId xmlns:a16="http://schemas.microsoft.com/office/drawing/2014/main" id="{1A056758-8A67-4834-8894-E578693992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3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5" name="Rectangle 550">
              <a:extLst>
                <a:ext uri="{FF2B5EF4-FFF2-40B4-BE49-F238E27FC236}">
                  <a16:creationId xmlns:a16="http://schemas.microsoft.com/office/drawing/2014/main" id="{BD78E62C-2FAB-4CCF-819F-D3BDB4B540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2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6" name="Line 551">
              <a:extLst>
                <a:ext uri="{FF2B5EF4-FFF2-40B4-BE49-F238E27FC236}">
                  <a16:creationId xmlns:a16="http://schemas.microsoft.com/office/drawing/2014/main" id="{D36D3571-6682-49E3-B035-05195633E3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3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7" name="Rectangle 552">
              <a:extLst>
                <a:ext uri="{FF2B5EF4-FFF2-40B4-BE49-F238E27FC236}">
                  <a16:creationId xmlns:a16="http://schemas.microsoft.com/office/drawing/2014/main" id="{34FB6ACB-42D8-4E53-B84A-24A1C60D90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2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8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8" name="Line 553">
              <a:extLst>
                <a:ext uri="{FF2B5EF4-FFF2-40B4-BE49-F238E27FC236}">
                  <a16:creationId xmlns:a16="http://schemas.microsoft.com/office/drawing/2014/main" id="{784B2F69-3C02-4369-B68D-B46F28E6A9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9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9" name="Rectangle 554">
              <a:extLst>
                <a:ext uri="{FF2B5EF4-FFF2-40B4-BE49-F238E27FC236}">
                  <a16:creationId xmlns:a16="http://schemas.microsoft.com/office/drawing/2014/main" id="{AC7E3528-68CE-4E2D-A357-2BA76A14FC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8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0" name="Line 555">
              <a:extLst>
                <a:ext uri="{FF2B5EF4-FFF2-40B4-BE49-F238E27FC236}">
                  <a16:creationId xmlns:a16="http://schemas.microsoft.com/office/drawing/2014/main" id="{6C3977D9-BAE2-4407-BB9E-6B4BB3C97B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9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1" name="Rectangle 556">
              <a:extLst>
                <a:ext uri="{FF2B5EF4-FFF2-40B4-BE49-F238E27FC236}">
                  <a16:creationId xmlns:a16="http://schemas.microsoft.com/office/drawing/2014/main" id="{20FEBFAC-257A-4DBA-89B1-213D413F5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8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2" name="Line 557">
              <a:extLst>
                <a:ext uri="{FF2B5EF4-FFF2-40B4-BE49-F238E27FC236}">
                  <a16:creationId xmlns:a16="http://schemas.microsoft.com/office/drawing/2014/main" id="{0559A7A2-7226-4C5D-9077-034E3254A0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6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3" name="Rectangle 558">
              <a:extLst>
                <a:ext uri="{FF2B5EF4-FFF2-40B4-BE49-F238E27FC236}">
                  <a16:creationId xmlns:a16="http://schemas.microsoft.com/office/drawing/2014/main" id="{675CBECA-862F-4406-92A6-351B5DAF70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5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4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4" name="Line 559">
              <a:extLst>
                <a:ext uri="{FF2B5EF4-FFF2-40B4-BE49-F238E27FC236}">
                  <a16:creationId xmlns:a16="http://schemas.microsoft.com/office/drawing/2014/main" id="{008C85C0-1A0C-446E-A880-D1EF354126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5" name="Rectangle 560">
              <a:extLst>
                <a:ext uri="{FF2B5EF4-FFF2-40B4-BE49-F238E27FC236}">
                  <a16:creationId xmlns:a16="http://schemas.microsoft.com/office/drawing/2014/main" id="{6707A663-E381-4310-870C-BE350A0CD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5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6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6" name="Line 561">
              <a:extLst>
                <a:ext uri="{FF2B5EF4-FFF2-40B4-BE49-F238E27FC236}">
                  <a16:creationId xmlns:a16="http://schemas.microsoft.com/office/drawing/2014/main" id="{2653459B-8AEF-4777-AFB7-7E2F4F6221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2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7" name="Rectangle 562">
              <a:extLst>
                <a:ext uri="{FF2B5EF4-FFF2-40B4-BE49-F238E27FC236}">
                  <a16:creationId xmlns:a16="http://schemas.microsoft.com/office/drawing/2014/main" id="{B9CD9827-173F-4AD7-AABC-A7278674A7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1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8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8" name="Line 563">
              <a:extLst>
                <a:ext uri="{FF2B5EF4-FFF2-40B4-BE49-F238E27FC236}">
                  <a16:creationId xmlns:a16="http://schemas.microsoft.com/office/drawing/2014/main" id="{B1573953-073D-4E88-B6B9-8F5464E9C6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2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9" name="Rectangle 564">
              <a:extLst>
                <a:ext uri="{FF2B5EF4-FFF2-40B4-BE49-F238E27FC236}">
                  <a16:creationId xmlns:a16="http://schemas.microsoft.com/office/drawing/2014/main" id="{3B8CA2B9-5D67-4EC8-BACE-C075EB7308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1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0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0" name="Line 565">
              <a:extLst>
                <a:ext uri="{FF2B5EF4-FFF2-40B4-BE49-F238E27FC236}">
                  <a16:creationId xmlns:a16="http://schemas.microsoft.com/office/drawing/2014/main" id="{3A7B32AF-12BB-4609-BC26-8D28A12011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9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1" name="Rectangle 566">
              <a:extLst>
                <a:ext uri="{FF2B5EF4-FFF2-40B4-BE49-F238E27FC236}">
                  <a16:creationId xmlns:a16="http://schemas.microsoft.com/office/drawing/2014/main" id="{620836F6-BCD1-4F3D-B226-A751A05F45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8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2" name="Line 567">
              <a:extLst>
                <a:ext uri="{FF2B5EF4-FFF2-40B4-BE49-F238E27FC236}">
                  <a16:creationId xmlns:a16="http://schemas.microsoft.com/office/drawing/2014/main" id="{C7BA6DD0-2F81-4B55-936E-F856E2652C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9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3" name="Rectangle 568">
              <a:extLst>
                <a:ext uri="{FF2B5EF4-FFF2-40B4-BE49-F238E27FC236}">
                  <a16:creationId xmlns:a16="http://schemas.microsoft.com/office/drawing/2014/main" id="{63B287DC-2EA7-42D8-8195-917634E816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8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4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4" name="Line 569">
              <a:extLst>
                <a:ext uri="{FF2B5EF4-FFF2-40B4-BE49-F238E27FC236}">
                  <a16:creationId xmlns:a16="http://schemas.microsoft.com/office/drawing/2014/main" id="{3A5E58FE-8BA6-4FAC-A9B1-976DAA564F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9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5" name="Rectangle 570">
              <a:extLst>
                <a:ext uri="{FF2B5EF4-FFF2-40B4-BE49-F238E27FC236}">
                  <a16:creationId xmlns:a16="http://schemas.microsoft.com/office/drawing/2014/main" id="{927036F2-572B-446A-97CA-4AAC7206C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8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6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6" name="Line 571">
              <a:extLst>
                <a:ext uri="{FF2B5EF4-FFF2-40B4-BE49-F238E27FC236}">
                  <a16:creationId xmlns:a16="http://schemas.microsoft.com/office/drawing/2014/main" id="{A0FFA070-429E-4259-8067-F79B5CECC4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25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7" name="Rectangle 572">
              <a:extLst>
                <a:ext uri="{FF2B5EF4-FFF2-40B4-BE49-F238E27FC236}">
                  <a16:creationId xmlns:a16="http://schemas.microsoft.com/office/drawing/2014/main" id="{6EA94DA7-7252-4E62-85C0-607FCF0DD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4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8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8" name="Line 573">
              <a:extLst>
                <a:ext uri="{FF2B5EF4-FFF2-40B4-BE49-F238E27FC236}">
                  <a16:creationId xmlns:a16="http://schemas.microsoft.com/office/drawing/2014/main" id="{313FD2A6-8C94-4AEE-8E41-14EF744C52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5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9" name="Rectangle 574">
              <a:extLst>
                <a:ext uri="{FF2B5EF4-FFF2-40B4-BE49-F238E27FC236}">
                  <a16:creationId xmlns:a16="http://schemas.microsoft.com/office/drawing/2014/main" id="{F631E374-23C9-4E19-97BD-3247548E34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4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70" name="Line 575">
              <a:extLst>
                <a:ext uri="{FF2B5EF4-FFF2-40B4-BE49-F238E27FC236}">
                  <a16:creationId xmlns:a16="http://schemas.microsoft.com/office/drawing/2014/main" id="{8B5EF789-DAC8-4D23-8278-1660A779E8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2" y="3596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1" name="Rectangle 576">
              <a:extLst>
                <a:ext uri="{FF2B5EF4-FFF2-40B4-BE49-F238E27FC236}">
                  <a16:creationId xmlns:a16="http://schemas.microsoft.com/office/drawing/2014/main" id="{12625CAA-3DA7-4CB7-95E2-BC91D2C34F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1" y="3627"/>
              <a:ext cx="16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20</a:t>
              </a: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72" name="Rectangle 577">
              <a:extLst>
                <a:ext uri="{FF2B5EF4-FFF2-40B4-BE49-F238E27FC236}">
                  <a16:creationId xmlns:a16="http://schemas.microsoft.com/office/drawing/2014/main" id="{1AFF4D37-EC3C-4623-9F31-771C95A506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" y="3890"/>
              <a:ext cx="209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/z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73" name="Line 578">
              <a:extLst>
                <a:ext uri="{FF2B5EF4-FFF2-40B4-BE49-F238E27FC236}">
                  <a16:creationId xmlns:a16="http://schemas.microsoft.com/office/drawing/2014/main" id="{9BA95362-C716-4A58-9D7B-FF73A6290F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" y="2635"/>
              <a:ext cx="0" cy="9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4" name="Line 579">
              <a:extLst>
                <a:ext uri="{FF2B5EF4-FFF2-40B4-BE49-F238E27FC236}">
                  <a16:creationId xmlns:a16="http://schemas.microsoft.com/office/drawing/2014/main" id="{7D748343-DAFB-4091-A879-C164638575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575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5" name="Line 580">
              <a:extLst>
                <a:ext uri="{FF2B5EF4-FFF2-40B4-BE49-F238E27FC236}">
                  <a16:creationId xmlns:a16="http://schemas.microsoft.com/office/drawing/2014/main" id="{FCF1CF40-8D1D-400C-B40B-E54173517A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557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6" name="Line 581">
              <a:extLst>
                <a:ext uri="{FF2B5EF4-FFF2-40B4-BE49-F238E27FC236}">
                  <a16:creationId xmlns:a16="http://schemas.microsoft.com/office/drawing/2014/main" id="{94C5BB99-8C2C-43FE-B623-81545DB94A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536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7" name="Line 582">
              <a:extLst>
                <a:ext uri="{FF2B5EF4-FFF2-40B4-BE49-F238E27FC236}">
                  <a16:creationId xmlns:a16="http://schemas.microsoft.com/office/drawing/2014/main" id="{711A3363-CB39-44CE-94DA-F707E83499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519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8" name="Line 583">
              <a:extLst>
                <a:ext uri="{FF2B5EF4-FFF2-40B4-BE49-F238E27FC236}">
                  <a16:creationId xmlns:a16="http://schemas.microsoft.com/office/drawing/2014/main" id="{B3B1B036-7431-4698-AE37-AB985BF378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480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9" name="Line 584">
              <a:extLst>
                <a:ext uri="{FF2B5EF4-FFF2-40B4-BE49-F238E27FC236}">
                  <a16:creationId xmlns:a16="http://schemas.microsoft.com/office/drawing/2014/main" id="{EA455A06-F1C6-4D31-AFD4-6485B2F05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459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0" name="Line 585">
              <a:extLst>
                <a:ext uri="{FF2B5EF4-FFF2-40B4-BE49-F238E27FC236}">
                  <a16:creationId xmlns:a16="http://schemas.microsoft.com/office/drawing/2014/main" id="{8C98264F-3366-4978-B898-C0AF4077F5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441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1" name="Line 586">
              <a:extLst>
                <a:ext uri="{FF2B5EF4-FFF2-40B4-BE49-F238E27FC236}">
                  <a16:creationId xmlns:a16="http://schemas.microsoft.com/office/drawing/2014/main" id="{63A8AFB7-60BE-40A2-9D08-52F78795B6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420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2" name="Line 587">
              <a:extLst>
                <a:ext uri="{FF2B5EF4-FFF2-40B4-BE49-F238E27FC236}">
                  <a16:creationId xmlns:a16="http://schemas.microsoft.com/office/drawing/2014/main" id="{5156B9A8-3C76-4C42-91F0-49C1E1123F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382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3" name="Line 588">
              <a:extLst>
                <a:ext uri="{FF2B5EF4-FFF2-40B4-BE49-F238E27FC236}">
                  <a16:creationId xmlns:a16="http://schemas.microsoft.com/office/drawing/2014/main" id="{15DA569E-2356-4944-A1E6-C3EC14F778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364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4" name="Line 589">
              <a:extLst>
                <a:ext uri="{FF2B5EF4-FFF2-40B4-BE49-F238E27FC236}">
                  <a16:creationId xmlns:a16="http://schemas.microsoft.com/office/drawing/2014/main" id="{829BB74C-6863-4647-9874-0E49626EFB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347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5" name="Line 590">
              <a:extLst>
                <a:ext uri="{FF2B5EF4-FFF2-40B4-BE49-F238E27FC236}">
                  <a16:creationId xmlns:a16="http://schemas.microsoft.com/office/drawing/2014/main" id="{24BCF669-14D7-4D11-879A-FF2C55B3C5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326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6" name="Line 591">
              <a:extLst>
                <a:ext uri="{FF2B5EF4-FFF2-40B4-BE49-F238E27FC236}">
                  <a16:creationId xmlns:a16="http://schemas.microsoft.com/office/drawing/2014/main" id="{72CD93BD-80D4-438A-AC9F-C35F80D965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287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7" name="Line 592">
              <a:extLst>
                <a:ext uri="{FF2B5EF4-FFF2-40B4-BE49-F238E27FC236}">
                  <a16:creationId xmlns:a16="http://schemas.microsoft.com/office/drawing/2014/main" id="{B0B8A506-3ED8-45CB-86D2-4CEE11C62E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270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8" name="Line 593">
              <a:extLst>
                <a:ext uri="{FF2B5EF4-FFF2-40B4-BE49-F238E27FC236}">
                  <a16:creationId xmlns:a16="http://schemas.microsoft.com/office/drawing/2014/main" id="{423DD1EB-F7DB-4EB6-9FA1-2880A1F82A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248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9" name="Line 594">
              <a:extLst>
                <a:ext uri="{FF2B5EF4-FFF2-40B4-BE49-F238E27FC236}">
                  <a16:creationId xmlns:a16="http://schemas.microsoft.com/office/drawing/2014/main" id="{A54ACC17-2FE8-4001-AA9B-C25B2A5229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231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0" name="Line 595">
              <a:extLst>
                <a:ext uri="{FF2B5EF4-FFF2-40B4-BE49-F238E27FC236}">
                  <a16:creationId xmlns:a16="http://schemas.microsoft.com/office/drawing/2014/main" id="{373BC8DD-CCEB-4DE6-ACC1-EFA9F5847D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192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1" name="Line 596">
              <a:extLst>
                <a:ext uri="{FF2B5EF4-FFF2-40B4-BE49-F238E27FC236}">
                  <a16:creationId xmlns:a16="http://schemas.microsoft.com/office/drawing/2014/main" id="{16B09BA8-F5D9-49E6-8AA3-970D3FE500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171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2" name="Line 597">
              <a:extLst>
                <a:ext uri="{FF2B5EF4-FFF2-40B4-BE49-F238E27FC236}">
                  <a16:creationId xmlns:a16="http://schemas.microsoft.com/office/drawing/2014/main" id="{AD6A87BB-9BFE-42C4-B365-8C9F23A65A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154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3" name="Line 598">
              <a:extLst>
                <a:ext uri="{FF2B5EF4-FFF2-40B4-BE49-F238E27FC236}">
                  <a16:creationId xmlns:a16="http://schemas.microsoft.com/office/drawing/2014/main" id="{FF023A31-635A-4235-80CC-9F241F545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133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4" name="Line 599">
              <a:extLst>
                <a:ext uri="{FF2B5EF4-FFF2-40B4-BE49-F238E27FC236}">
                  <a16:creationId xmlns:a16="http://schemas.microsoft.com/office/drawing/2014/main" id="{F2613CD9-6911-491F-AE4E-0602AF60DC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098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5" name="Line 600">
              <a:extLst>
                <a:ext uri="{FF2B5EF4-FFF2-40B4-BE49-F238E27FC236}">
                  <a16:creationId xmlns:a16="http://schemas.microsoft.com/office/drawing/2014/main" id="{97DC3D6C-BC5D-4A8F-9A45-C4D667AEDC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077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6" name="Line 601">
              <a:extLst>
                <a:ext uri="{FF2B5EF4-FFF2-40B4-BE49-F238E27FC236}">
                  <a16:creationId xmlns:a16="http://schemas.microsoft.com/office/drawing/2014/main" id="{F4DF0E33-F971-44A1-A27B-1F22C1CECE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059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7" name="Line 602">
              <a:extLst>
                <a:ext uri="{FF2B5EF4-FFF2-40B4-BE49-F238E27FC236}">
                  <a16:creationId xmlns:a16="http://schemas.microsoft.com/office/drawing/2014/main" id="{C781B974-071E-4E3D-95BC-B0A4CBCE96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3038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8" name="Line 603">
              <a:extLst>
                <a:ext uri="{FF2B5EF4-FFF2-40B4-BE49-F238E27FC236}">
                  <a16:creationId xmlns:a16="http://schemas.microsoft.com/office/drawing/2014/main" id="{15F3048C-0FD1-4568-98A0-8743907DC0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2999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9" name="Line 604">
              <a:extLst>
                <a:ext uri="{FF2B5EF4-FFF2-40B4-BE49-F238E27FC236}">
                  <a16:creationId xmlns:a16="http://schemas.microsoft.com/office/drawing/2014/main" id="{6783E7A3-FC9A-426D-89AE-1E05E83F7E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2982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0" name="Line 605">
              <a:extLst>
                <a:ext uri="{FF2B5EF4-FFF2-40B4-BE49-F238E27FC236}">
                  <a16:creationId xmlns:a16="http://schemas.microsoft.com/office/drawing/2014/main" id="{FFCEB148-F285-4723-B5DE-AFE4D73D22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2961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1" name="Line 606">
              <a:extLst>
                <a:ext uri="{FF2B5EF4-FFF2-40B4-BE49-F238E27FC236}">
                  <a16:creationId xmlns:a16="http://schemas.microsoft.com/office/drawing/2014/main" id="{2F9BB6A6-723A-469A-B96B-EE7843D696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45" y="2943"/>
              <a:ext cx="2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Line 608">
            <a:extLst>
              <a:ext uri="{FF2B5EF4-FFF2-40B4-BE49-F238E27FC236}">
                <a16:creationId xmlns:a16="http://schemas.microsoft.com/office/drawing/2014/main" id="{AB655B7E-4A11-4F8F-89C7-D77EAE29BB6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4101380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Line 609">
            <a:extLst>
              <a:ext uri="{FF2B5EF4-FFF2-40B4-BE49-F238E27FC236}">
                <a16:creationId xmlns:a16="http://schemas.microsoft.com/office/drawing/2014/main" id="{7DD9C782-BB47-43EA-B682-29ACD41AAC9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4068042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Line 610">
            <a:extLst>
              <a:ext uri="{FF2B5EF4-FFF2-40B4-BE49-F238E27FC236}">
                <a16:creationId xmlns:a16="http://schemas.microsoft.com/office/drawing/2014/main" id="{614FD8D5-A37F-4AD5-8578-A7029B44D82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4039467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611">
            <a:extLst>
              <a:ext uri="{FF2B5EF4-FFF2-40B4-BE49-F238E27FC236}">
                <a16:creationId xmlns:a16="http://schemas.microsoft.com/office/drawing/2014/main" id="{2B293E4A-B18A-4D5B-87CC-AFCBB6DB95C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4012480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612">
            <a:extLst>
              <a:ext uri="{FF2B5EF4-FFF2-40B4-BE49-F238E27FC236}">
                <a16:creationId xmlns:a16="http://schemas.microsoft.com/office/drawing/2014/main" id="{CADD1B35-EEBD-4834-967F-5009F49E399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950567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613">
            <a:extLst>
              <a:ext uri="{FF2B5EF4-FFF2-40B4-BE49-F238E27FC236}">
                <a16:creationId xmlns:a16="http://schemas.microsoft.com/office/drawing/2014/main" id="{15EF10E0-A708-451F-A0D3-2567C8AB315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917230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614">
            <a:extLst>
              <a:ext uri="{FF2B5EF4-FFF2-40B4-BE49-F238E27FC236}">
                <a16:creationId xmlns:a16="http://schemas.microsoft.com/office/drawing/2014/main" id="{80D63AD0-4C5A-4784-9D0A-0944DF4A6B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890242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615">
            <a:extLst>
              <a:ext uri="{FF2B5EF4-FFF2-40B4-BE49-F238E27FC236}">
                <a16:creationId xmlns:a16="http://schemas.microsoft.com/office/drawing/2014/main" id="{6657C80F-C4CD-4E2C-8BE8-1327D5BF5CC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856905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616">
            <a:extLst>
              <a:ext uri="{FF2B5EF4-FFF2-40B4-BE49-F238E27FC236}">
                <a16:creationId xmlns:a16="http://schemas.microsoft.com/office/drawing/2014/main" id="{8F4962F2-68F4-4568-A66D-3FC81B63045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794992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617">
            <a:extLst>
              <a:ext uri="{FF2B5EF4-FFF2-40B4-BE49-F238E27FC236}">
                <a16:creationId xmlns:a16="http://schemas.microsoft.com/office/drawing/2014/main" id="{84360C92-31CE-484C-A708-9DD6C78D116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766417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618">
            <a:extLst>
              <a:ext uri="{FF2B5EF4-FFF2-40B4-BE49-F238E27FC236}">
                <a16:creationId xmlns:a16="http://schemas.microsoft.com/office/drawing/2014/main" id="{78583A62-593F-41F4-9B99-04287290842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733080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619">
            <a:extLst>
              <a:ext uri="{FF2B5EF4-FFF2-40B4-BE49-F238E27FC236}">
                <a16:creationId xmlns:a16="http://schemas.microsoft.com/office/drawing/2014/main" id="{AF42B302-A29B-4E4E-9818-B9C0352B0AE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66041" y="3706092"/>
            <a:ext cx="333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620">
            <a:extLst>
              <a:ext uri="{FF2B5EF4-FFF2-40B4-BE49-F238E27FC236}">
                <a16:creationId xmlns:a16="http://schemas.microsoft.com/office/drawing/2014/main" id="{473DCE76-6701-4B21-B72A-A33B0E9335D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519199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621">
            <a:extLst>
              <a:ext uri="{FF2B5EF4-FFF2-40B4-BE49-F238E27FC236}">
                <a16:creationId xmlns:a16="http://schemas.microsoft.com/office/drawing/2014/main" id="{73014DFF-6E18-4C45-9B17-5A4585D3F9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634" y="514006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" name="Line 622">
            <a:extLst>
              <a:ext uri="{FF2B5EF4-FFF2-40B4-BE49-F238E27FC236}">
                <a16:creationId xmlns:a16="http://schemas.microsoft.com/office/drawing/2014/main" id="{C5CE1ED7-EAB0-4867-B9CB-C46B576A303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504118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624">
            <a:extLst>
              <a:ext uri="{FF2B5EF4-FFF2-40B4-BE49-F238E27FC236}">
                <a16:creationId xmlns:a16="http://schemas.microsoft.com/office/drawing/2014/main" id="{DFA7FD3C-861C-4241-B82E-F40B43C86D4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8919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625">
            <a:extLst>
              <a:ext uri="{FF2B5EF4-FFF2-40B4-BE49-F238E27FC236}">
                <a16:creationId xmlns:a16="http://schemas.microsoft.com/office/drawing/2014/main" id="{FCAEDD4F-A332-4DE5-9F96-8FC6754CEF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293" y="4837669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Line 626">
            <a:extLst>
              <a:ext uri="{FF2B5EF4-FFF2-40B4-BE49-F238E27FC236}">
                <a16:creationId xmlns:a16="http://schemas.microsoft.com/office/drawing/2014/main" id="{97570155-A2B4-44D8-B83E-656C96DDD13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7411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Line 628">
            <a:extLst>
              <a:ext uri="{FF2B5EF4-FFF2-40B4-BE49-F238E27FC236}">
                <a16:creationId xmlns:a16="http://schemas.microsoft.com/office/drawing/2014/main" id="{3D6828DF-DE35-468D-B86C-D1BF2093655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5855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629">
            <a:extLst>
              <a:ext uri="{FF2B5EF4-FFF2-40B4-BE49-F238E27FC236}">
                <a16:creationId xmlns:a16="http://schemas.microsoft.com/office/drawing/2014/main" id="{249A6E50-9B02-445D-837A-BD4CCC6465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859" y="454827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" name="Line 630">
            <a:extLst>
              <a:ext uri="{FF2B5EF4-FFF2-40B4-BE49-F238E27FC236}">
                <a16:creationId xmlns:a16="http://schemas.microsoft.com/office/drawing/2014/main" id="{DD99CC70-2927-4D6C-A1D0-12C2BD11E60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4347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ine 632">
            <a:extLst>
              <a:ext uri="{FF2B5EF4-FFF2-40B4-BE49-F238E27FC236}">
                <a16:creationId xmlns:a16="http://schemas.microsoft.com/office/drawing/2014/main" id="{8526B1F8-7FD3-4E4D-AEB5-84A8BDD69D7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2855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Rectangle 633">
            <a:extLst>
              <a:ext uri="{FF2B5EF4-FFF2-40B4-BE49-F238E27FC236}">
                <a16:creationId xmlns:a16="http://schemas.microsoft.com/office/drawing/2014/main" id="{26538CC8-6121-4DB1-9916-32B42BBCDB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3579" y="4203394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25" name="Line 634">
            <a:extLst>
              <a:ext uri="{FF2B5EF4-FFF2-40B4-BE49-F238E27FC236}">
                <a16:creationId xmlns:a16="http://schemas.microsoft.com/office/drawing/2014/main" id="{B3EE0BD3-6EA3-4DED-986E-9B922AE3C97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4128367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8" name="Line 636">
            <a:extLst>
              <a:ext uri="{FF2B5EF4-FFF2-40B4-BE49-F238E27FC236}">
                <a16:creationId xmlns:a16="http://schemas.microsoft.com/office/drawing/2014/main" id="{058AA2F3-EBD3-4E83-A2DD-2053D0768DC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3979142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9" name="Rectangle 637">
            <a:extLst>
              <a:ext uri="{FF2B5EF4-FFF2-40B4-BE49-F238E27FC236}">
                <a16:creationId xmlns:a16="http://schemas.microsoft.com/office/drawing/2014/main" id="{607B6E3D-8E8F-4CE8-A563-B87B4433DC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022" y="38992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0" name="Line 638">
            <a:extLst>
              <a:ext uri="{FF2B5EF4-FFF2-40B4-BE49-F238E27FC236}">
                <a16:creationId xmlns:a16="http://schemas.microsoft.com/office/drawing/2014/main" id="{7FEBA7AF-AD24-4F23-8A2F-A54FE413DDB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3828330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2" name="Line 640">
            <a:extLst>
              <a:ext uri="{FF2B5EF4-FFF2-40B4-BE49-F238E27FC236}">
                <a16:creationId xmlns:a16="http://schemas.microsoft.com/office/drawing/2014/main" id="{ADBCE108-D4AC-4122-9F6F-61646813989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0166" y="3672755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Rectangle 641">
            <a:extLst>
              <a:ext uri="{FF2B5EF4-FFF2-40B4-BE49-F238E27FC236}">
                <a16:creationId xmlns:a16="http://schemas.microsoft.com/office/drawing/2014/main" id="{9A6A0551-A279-48BB-9251-253AC5C3BA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460" y="3577340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4" name="Rectangle 642">
            <a:extLst>
              <a:ext uri="{FF2B5EF4-FFF2-40B4-BE49-F238E27FC236}">
                <a16:creationId xmlns:a16="http://schemas.microsoft.com/office/drawing/2014/main" id="{70C07CC4-F544-4645-B811-7C672183D03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58844" y="4282817"/>
            <a:ext cx="13621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elative Abundan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5" name="Freeform 643">
            <a:extLst>
              <a:ext uri="{FF2B5EF4-FFF2-40B4-BE49-F238E27FC236}">
                <a16:creationId xmlns:a16="http://schemas.microsoft.com/office/drawing/2014/main" id="{B49CEBCB-A831-4D68-BA85-31EB57CFFE67}"/>
              </a:ext>
            </a:extLst>
          </p:cNvPr>
          <p:cNvSpPr>
            <a:spLocks/>
          </p:cNvSpPr>
          <p:nvPr/>
        </p:nvSpPr>
        <p:spPr bwMode="auto">
          <a:xfrm>
            <a:off x="799379" y="3672755"/>
            <a:ext cx="8094663" cy="1519238"/>
          </a:xfrm>
          <a:custGeom>
            <a:avLst/>
            <a:gdLst>
              <a:gd name="T0" fmla="*/ 21 w 1454"/>
              <a:gd name="T1" fmla="*/ 272 h 273"/>
              <a:gd name="T2" fmla="*/ 23 w 1454"/>
              <a:gd name="T3" fmla="*/ 272 h 273"/>
              <a:gd name="T4" fmla="*/ 65 w 1454"/>
              <a:gd name="T5" fmla="*/ 221 h 273"/>
              <a:gd name="T6" fmla="*/ 130 w 1454"/>
              <a:gd name="T7" fmla="*/ 271 h 273"/>
              <a:gd name="T8" fmla="*/ 146 w 1454"/>
              <a:gd name="T9" fmla="*/ 272 h 273"/>
              <a:gd name="T10" fmla="*/ 160 w 1454"/>
              <a:gd name="T11" fmla="*/ 271 h 273"/>
              <a:gd name="T12" fmla="*/ 188 w 1454"/>
              <a:gd name="T13" fmla="*/ 272 h 273"/>
              <a:gd name="T14" fmla="*/ 214 w 1454"/>
              <a:gd name="T15" fmla="*/ 272 h 273"/>
              <a:gd name="T16" fmla="*/ 243 w 1454"/>
              <a:gd name="T17" fmla="*/ 272 h 273"/>
              <a:gd name="T18" fmla="*/ 245 w 1454"/>
              <a:gd name="T19" fmla="*/ 272 h 273"/>
              <a:gd name="T20" fmla="*/ 283 w 1454"/>
              <a:gd name="T21" fmla="*/ 264 h 273"/>
              <a:gd name="T22" fmla="*/ 290 w 1454"/>
              <a:gd name="T23" fmla="*/ 273 h 273"/>
              <a:gd name="T24" fmla="*/ 291 w 1454"/>
              <a:gd name="T25" fmla="*/ 273 h 273"/>
              <a:gd name="T26" fmla="*/ 348 w 1454"/>
              <a:gd name="T27" fmla="*/ 273 h 273"/>
              <a:gd name="T28" fmla="*/ 390 w 1454"/>
              <a:gd name="T29" fmla="*/ 273 h 273"/>
              <a:gd name="T30" fmla="*/ 398 w 1454"/>
              <a:gd name="T31" fmla="*/ 273 h 273"/>
              <a:gd name="T32" fmla="*/ 402 w 1454"/>
              <a:gd name="T33" fmla="*/ 273 h 273"/>
              <a:gd name="T34" fmla="*/ 414 w 1454"/>
              <a:gd name="T35" fmla="*/ 273 h 273"/>
              <a:gd name="T36" fmla="*/ 440 w 1454"/>
              <a:gd name="T37" fmla="*/ 273 h 273"/>
              <a:gd name="T38" fmla="*/ 444 w 1454"/>
              <a:gd name="T39" fmla="*/ 273 h 273"/>
              <a:gd name="T40" fmla="*/ 448 w 1454"/>
              <a:gd name="T41" fmla="*/ 273 h 273"/>
              <a:gd name="T42" fmla="*/ 451 w 1454"/>
              <a:gd name="T43" fmla="*/ 273 h 273"/>
              <a:gd name="T44" fmla="*/ 455 w 1454"/>
              <a:gd name="T45" fmla="*/ 273 h 273"/>
              <a:gd name="T46" fmla="*/ 459 w 1454"/>
              <a:gd name="T47" fmla="*/ 273 h 273"/>
              <a:gd name="T48" fmla="*/ 493 w 1454"/>
              <a:gd name="T49" fmla="*/ 273 h 273"/>
              <a:gd name="T50" fmla="*/ 497 w 1454"/>
              <a:gd name="T51" fmla="*/ 273 h 273"/>
              <a:gd name="T52" fmla="*/ 501 w 1454"/>
              <a:gd name="T53" fmla="*/ 273 h 273"/>
              <a:gd name="T54" fmla="*/ 513 w 1454"/>
              <a:gd name="T55" fmla="*/ 273 h 273"/>
              <a:gd name="T56" fmla="*/ 562 w 1454"/>
              <a:gd name="T57" fmla="*/ 273 h 273"/>
              <a:gd name="T58" fmla="*/ 566 w 1454"/>
              <a:gd name="T59" fmla="*/ 273 h 273"/>
              <a:gd name="T60" fmla="*/ 604 w 1454"/>
              <a:gd name="T61" fmla="*/ 270 h 273"/>
              <a:gd name="T62" fmla="*/ 620 w 1454"/>
              <a:gd name="T63" fmla="*/ 273 h 273"/>
              <a:gd name="T64" fmla="*/ 658 w 1454"/>
              <a:gd name="T65" fmla="*/ 273 h 273"/>
              <a:gd name="T66" fmla="*/ 673 w 1454"/>
              <a:gd name="T67" fmla="*/ 273 h 273"/>
              <a:gd name="T68" fmla="*/ 684 w 1454"/>
              <a:gd name="T69" fmla="*/ 273 h 273"/>
              <a:gd name="T70" fmla="*/ 685 w 1454"/>
              <a:gd name="T71" fmla="*/ 97 h 273"/>
              <a:gd name="T72" fmla="*/ 712 w 1454"/>
              <a:gd name="T73" fmla="*/ 259 h 273"/>
              <a:gd name="T74" fmla="*/ 727 w 1454"/>
              <a:gd name="T75" fmla="*/ 209 h 273"/>
              <a:gd name="T76" fmla="*/ 740 w 1454"/>
              <a:gd name="T77" fmla="*/ 272 h 273"/>
              <a:gd name="T78" fmla="*/ 753 w 1454"/>
              <a:gd name="T79" fmla="*/ 273 h 273"/>
              <a:gd name="T80" fmla="*/ 754 w 1454"/>
              <a:gd name="T81" fmla="*/ 273 h 273"/>
              <a:gd name="T82" fmla="*/ 826 w 1454"/>
              <a:gd name="T83" fmla="*/ 271 h 273"/>
              <a:gd name="T84" fmla="*/ 879 w 1454"/>
              <a:gd name="T85" fmla="*/ 273 h 273"/>
              <a:gd name="T86" fmla="*/ 956 w 1454"/>
              <a:gd name="T87" fmla="*/ 273 h 273"/>
              <a:gd name="T88" fmla="*/ 957 w 1454"/>
              <a:gd name="T89" fmla="*/ 53 h 273"/>
              <a:gd name="T90" fmla="*/ 972 w 1454"/>
              <a:gd name="T91" fmla="*/ 271 h 273"/>
              <a:gd name="T92" fmla="*/ 1002 w 1454"/>
              <a:gd name="T93" fmla="*/ 273 h 273"/>
              <a:gd name="T94" fmla="*/ 1003 w 1454"/>
              <a:gd name="T95" fmla="*/ 273 h 273"/>
              <a:gd name="T96" fmla="*/ 1106 w 1454"/>
              <a:gd name="T97" fmla="*/ 273 h 273"/>
              <a:gd name="T98" fmla="*/ 1175 w 1454"/>
              <a:gd name="T99" fmla="*/ 273 h 273"/>
              <a:gd name="T100" fmla="*/ 1217 w 1454"/>
              <a:gd name="T101" fmla="*/ 273 h 273"/>
              <a:gd name="T102" fmla="*/ 1282 w 1454"/>
              <a:gd name="T103" fmla="*/ 273 h 273"/>
              <a:gd name="T104" fmla="*/ 1351 w 1454"/>
              <a:gd name="T105" fmla="*/ 273 h 2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454" h="273">
                <a:moveTo>
                  <a:pt x="0" y="273"/>
                </a:moveTo>
                <a:lnTo>
                  <a:pt x="21" y="273"/>
                </a:lnTo>
                <a:lnTo>
                  <a:pt x="21" y="272"/>
                </a:lnTo>
                <a:lnTo>
                  <a:pt x="21" y="273"/>
                </a:lnTo>
                <a:lnTo>
                  <a:pt x="23" y="273"/>
                </a:lnTo>
                <a:lnTo>
                  <a:pt x="23" y="272"/>
                </a:lnTo>
                <a:lnTo>
                  <a:pt x="23" y="273"/>
                </a:lnTo>
                <a:lnTo>
                  <a:pt x="65" y="273"/>
                </a:lnTo>
                <a:lnTo>
                  <a:pt x="65" y="221"/>
                </a:lnTo>
                <a:lnTo>
                  <a:pt x="65" y="273"/>
                </a:lnTo>
                <a:lnTo>
                  <a:pt x="130" y="273"/>
                </a:lnTo>
                <a:lnTo>
                  <a:pt x="130" y="271"/>
                </a:lnTo>
                <a:lnTo>
                  <a:pt x="130" y="273"/>
                </a:lnTo>
                <a:lnTo>
                  <a:pt x="146" y="273"/>
                </a:lnTo>
                <a:lnTo>
                  <a:pt x="146" y="272"/>
                </a:lnTo>
                <a:lnTo>
                  <a:pt x="146" y="273"/>
                </a:lnTo>
                <a:lnTo>
                  <a:pt x="160" y="273"/>
                </a:lnTo>
                <a:lnTo>
                  <a:pt x="160" y="271"/>
                </a:lnTo>
                <a:lnTo>
                  <a:pt x="160" y="273"/>
                </a:lnTo>
                <a:lnTo>
                  <a:pt x="188" y="273"/>
                </a:lnTo>
                <a:lnTo>
                  <a:pt x="188" y="272"/>
                </a:lnTo>
                <a:lnTo>
                  <a:pt x="188" y="273"/>
                </a:lnTo>
                <a:lnTo>
                  <a:pt x="214" y="273"/>
                </a:lnTo>
                <a:lnTo>
                  <a:pt x="214" y="272"/>
                </a:lnTo>
                <a:lnTo>
                  <a:pt x="214" y="273"/>
                </a:lnTo>
                <a:lnTo>
                  <a:pt x="243" y="273"/>
                </a:lnTo>
                <a:lnTo>
                  <a:pt x="243" y="272"/>
                </a:lnTo>
                <a:lnTo>
                  <a:pt x="243" y="273"/>
                </a:lnTo>
                <a:lnTo>
                  <a:pt x="245" y="273"/>
                </a:lnTo>
                <a:lnTo>
                  <a:pt x="245" y="272"/>
                </a:lnTo>
                <a:lnTo>
                  <a:pt x="245" y="273"/>
                </a:lnTo>
                <a:lnTo>
                  <a:pt x="283" y="273"/>
                </a:lnTo>
                <a:lnTo>
                  <a:pt x="283" y="264"/>
                </a:lnTo>
                <a:lnTo>
                  <a:pt x="283" y="273"/>
                </a:lnTo>
                <a:lnTo>
                  <a:pt x="290" y="273"/>
                </a:lnTo>
                <a:lnTo>
                  <a:pt x="290" y="273"/>
                </a:lnTo>
                <a:lnTo>
                  <a:pt x="290" y="270"/>
                </a:lnTo>
                <a:lnTo>
                  <a:pt x="291" y="272"/>
                </a:lnTo>
                <a:lnTo>
                  <a:pt x="291" y="273"/>
                </a:lnTo>
                <a:lnTo>
                  <a:pt x="348" y="273"/>
                </a:lnTo>
                <a:lnTo>
                  <a:pt x="348" y="264"/>
                </a:lnTo>
                <a:lnTo>
                  <a:pt x="348" y="273"/>
                </a:lnTo>
                <a:lnTo>
                  <a:pt x="390" y="273"/>
                </a:lnTo>
                <a:lnTo>
                  <a:pt x="390" y="237"/>
                </a:lnTo>
                <a:lnTo>
                  <a:pt x="390" y="273"/>
                </a:lnTo>
                <a:lnTo>
                  <a:pt x="398" y="273"/>
                </a:lnTo>
                <a:lnTo>
                  <a:pt x="398" y="271"/>
                </a:lnTo>
                <a:lnTo>
                  <a:pt x="398" y="273"/>
                </a:lnTo>
                <a:lnTo>
                  <a:pt x="402" y="273"/>
                </a:lnTo>
                <a:lnTo>
                  <a:pt x="402" y="269"/>
                </a:lnTo>
                <a:lnTo>
                  <a:pt x="402" y="273"/>
                </a:lnTo>
                <a:lnTo>
                  <a:pt x="414" y="273"/>
                </a:lnTo>
                <a:lnTo>
                  <a:pt x="414" y="272"/>
                </a:lnTo>
                <a:lnTo>
                  <a:pt x="414" y="273"/>
                </a:lnTo>
                <a:lnTo>
                  <a:pt x="440" y="273"/>
                </a:lnTo>
                <a:lnTo>
                  <a:pt x="440" y="124"/>
                </a:lnTo>
                <a:lnTo>
                  <a:pt x="440" y="273"/>
                </a:lnTo>
                <a:lnTo>
                  <a:pt x="444" y="273"/>
                </a:lnTo>
                <a:lnTo>
                  <a:pt x="444" y="0"/>
                </a:lnTo>
                <a:lnTo>
                  <a:pt x="444" y="273"/>
                </a:lnTo>
                <a:lnTo>
                  <a:pt x="448" y="273"/>
                </a:lnTo>
                <a:lnTo>
                  <a:pt x="448" y="270"/>
                </a:lnTo>
                <a:lnTo>
                  <a:pt x="448" y="273"/>
                </a:lnTo>
                <a:lnTo>
                  <a:pt x="451" y="273"/>
                </a:lnTo>
                <a:lnTo>
                  <a:pt x="451" y="257"/>
                </a:lnTo>
                <a:lnTo>
                  <a:pt x="451" y="273"/>
                </a:lnTo>
                <a:lnTo>
                  <a:pt x="455" y="273"/>
                </a:lnTo>
                <a:lnTo>
                  <a:pt x="455" y="199"/>
                </a:lnTo>
                <a:lnTo>
                  <a:pt x="455" y="273"/>
                </a:lnTo>
                <a:lnTo>
                  <a:pt x="459" y="273"/>
                </a:lnTo>
                <a:lnTo>
                  <a:pt x="459" y="270"/>
                </a:lnTo>
                <a:lnTo>
                  <a:pt x="459" y="273"/>
                </a:lnTo>
                <a:lnTo>
                  <a:pt x="493" y="273"/>
                </a:lnTo>
                <a:lnTo>
                  <a:pt x="493" y="271"/>
                </a:lnTo>
                <a:lnTo>
                  <a:pt x="493" y="273"/>
                </a:lnTo>
                <a:lnTo>
                  <a:pt x="497" y="273"/>
                </a:lnTo>
                <a:lnTo>
                  <a:pt x="497" y="271"/>
                </a:lnTo>
                <a:lnTo>
                  <a:pt x="497" y="273"/>
                </a:lnTo>
                <a:lnTo>
                  <a:pt x="501" y="273"/>
                </a:lnTo>
                <a:lnTo>
                  <a:pt x="501" y="234"/>
                </a:lnTo>
                <a:lnTo>
                  <a:pt x="501" y="273"/>
                </a:lnTo>
                <a:lnTo>
                  <a:pt x="513" y="273"/>
                </a:lnTo>
                <a:lnTo>
                  <a:pt x="513" y="261"/>
                </a:lnTo>
                <a:lnTo>
                  <a:pt x="513" y="273"/>
                </a:lnTo>
                <a:lnTo>
                  <a:pt x="562" y="273"/>
                </a:lnTo>
                <a:lnTo>
                  <a:pt x="562" y="258"/>
                </a:lnTo>
                <a:lnTo>
                  <a:pt x="562" y="273"/>
                </a:lnTo>
                <a:lnTo>
                  <a:pt x="566" y="273"/>
                </a:lnTo>
                <a:lnTo>
                  <a:pt x="566" y="239"/>
                </a:lnTo>
                <a:lnTo>
                  <a:pt x="566" y="273"/>
                </a:lnTo>
                <a:lnTo>
                  <a:pt x="604" y="273"/>
                </a:lnTo>
                <a:lnTo>
                  <a:pt x="604" y="273"/>
                </a:lnTo>
                <a:lnTo>
                  <a:pt x="604" y="270"/>
                </a:lnTo>
                <a:lnTo>
                  <a:pt x="605" y="272"/>
                </a:lnTo>
                <a:lnTo>
                  <a:pt x="605" y="273"/>
                </a:lnTo>
                <a:lnTo>
                  <a:pt x="620" y="273"/>
                </a:lnTo>
                <a:lnTo>
                  <a:pt x="620" y="271"/>
                </a:lnTo>
                <a:lnTo>
                  <a:pt x="620" y="273"/>
                </a:lnTo>
                <a:lnTo>
                  <a:pt x="658" y="273"/>
                </a:lnTo>
                <a:lnTo>
                  <a:pt x="658" y="230"/>
                </a:lnTo>
                <a:lnTo>
                  <a:pt x="658" y="273"/>
                </a:lnTo>
                <a:lnTo>
                  <a:pt x="673" y="273"/>
                </a:lnTo>
                <a:lnTo>
                  <a:pt x="673" y="270"/>
                </a:lnTo>
                <a:lnTo>
                  <a:pt x="673" y="273"/>
                </a:lnTo>
                <a:lnTo>
                  <a:pt x="684" y="273"/>
                </a:lnTo>
                <a:lnTo>
                  <a:pt x="684" y="273"/>
                </a:lnTo>
                <a:lnTo>
                  <a:pt x="684" y="273"/>
                </a:lnTo>
                <a:lnTo>
                  <a:pt x="685" y="97"/>
                </a:lnTo>
                <a:lnTo>
                  <a:pt x="685" y="273"/>
                </a:lnTo>
                <a:lnTo>
                  <a:pt x="712" y="273"/>
                </a:lnTo>
                <a:lnTo>
                  <a:pt x="712" y="259"/>
                </a:lnTo>
                <a:lnTo>
                  <a:pt x="712" y="273"/>
                </a:lnTo>
                <a:lnTo>
                  <a:pt x="727" y="273"/>
                </a:lnTo>
                <a:lnTo>
                  <a:pt x="727" y="209"/>
                </a:lnTo>
                <a:lnTo>
                  <a:pt x="727" y="273"/>
                </a:lnTo>
                <a:lnTo>
                  <a:pt x="740" y="273"/>
                </a:lnTo>
                <a:lnTo>
                  <a:pt x="740" y="272"/>
                </a:lnTo>
                <a:lnTo>
                  <a:pt x="740" y="273"/>
                </a:lnTo>
                <a:lnTo>
                  <a:pt x="753" y="273"/>
                </a:lnTo>
                <a:lnTo>
                  <a:pt x="753" y="273"/>
                </a:lnTo>
                <a:lnTo>
                  <a:pt x="753" y="264"/>
                </a:lnTo>
                <a:lnTo>
                  <a:pt x="754" y="134"/>
                </a:lnTo>
                <a:lnTo>
                  <a:pt x="754" y="273"/>
                </a:lnTo>
                <a:lnTo>
                  <a:pt x="826" y="273"/>
                </a:lnTo>
                <a:lnTo>
                  <a:pt x="826" y="273"/>
                </a:lnTo>
                <a:lnTo>
                  <a:pt x="826" y="271"/>
                </a:lnTo>
                <a:lnTo>
                  <a:pt x="827" y="272"/>
                </a:lnTo>
                <a:lnTo>
                  <a:pt x="827" y="273"/>
                </a:lnTo>
                <a:lnTo>
                  <a:pt x="879" y="273"/>
                </a:lnTo>
                <a:lnTo>
                  <a:pt x="879" y="272"/>
                </a:lnTo>
                <a:lnTo>
                  <a:pt x="879" y="273"/>
                </a:lnTo>
                <a:lnTo>
                  <a:pt x="956" y="273"/>
                </a:lnTo>
                <a:lnTo>
                  <a:pt x="956" y="273"/>
                </a:lnTo>
                <a:lnTo>
                  <a:pt x="956" y="270"/>
                </a:lnTo>
                <a:lnTo>
                  <a:pt x="957" y="53"/>
                </a:lnTo>
                <a:lnTo>
                  <a:pt x="957" y="273"/>
                </a:lnTo>
                <a:lnTo>
                  <a:pt x="972" y="273"/>
                </a:lnTo>
                <a:lnTo>
                  <a:pt x="972" y="271"/>
                </a:lnTo>
                <a:lnTo>
                  <a:pt x="972" y="273"/>
                </a:lnTo>
                <a:lnTo>
                  <a:pt x="1002" y="273"/>
                </a:lnTo>
                <a:lnTo>
                  <a:pt x="1002" y="273"/>
                </a:lnTo>
                <a:lnTo>
                  <a:pt x="1002" y="249"/>
                </a:lnTo>
                <a:lnTo>
                  <a:pt x="1003" y="256"/>
                </a:lnTo>
                <a:lnTo>
                  <a:pt x="1003" y="273"/>
                </a:lnTo>
                <a:lnTo>
                  <a:pt x="1106" y="273"/>
                </a:lnTo>
                <a:lnTo>
                  <a:pt x="1106" y="265"/>
                </a:lnTo>
                <a:lnTo>
                  <a:pt x="1106" y="273"/>
                </a:lnTo>
                <a:lnTo>
                  <a:pt x="1175" y="273"/>
                </a:lnTo>
                <a:lnTo>
                  <a:pt x="1175" y="259"/>
                </a:lnTo>
                <a:lnTo>
                  <a:pt x="1175" y="273"/>
                </a:lnTo>
                <a:lnTo>
                  <a:pt x="1217" y="273"/>
                </a:lnTo>
                <a:lnTo>
                  <a:pt x="1217" y="232"/>
                </a:lnTo>
                <a:lnTo>
                  <a:pt x="1217" y="273"/>
                </a:lnTo>
                <a:lnTo>
                  <a:pt x="1282" y="273"/>
                </a:lnTo>
                <a:lnTo>
                  <a:pt x="1282" y="266"/>
                </a:lnTo>
                <a:lnTo>
                  <a:pt x="1282" y="273"/>
                </a:lnTo>
                <a:lnTo>
                  <a:pt x="1351" y="273"/>
                </a:lnTo>
                <a:lnTo>
                  <a:pt x="1351" y="197"/>
                </a:lnTo>
                <a:lnTo>
                  <a:pt x="1351" y="273"/>
                </a:lnTo>
                <a:lnTo>
                  <a:pt x="1454" y="27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Rectangle 644">
            <a:extLst>
              <a:ext uri="{FF2B5EF4-FFF2-40B4-BE49-F238E27FC236}">
                <a16:creationId xmlns:a16="http://schemas.microsoft.com/office/drawing/2014/main" id="{DE6FC313-1278-423C-B803-03F608A77C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3086" y="3493072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0.0961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9" name="Rectangle 647">
            <a:extLst>
              <a:ext uri="{FF2B5EF4-FFF2-40B4-BE49-F238E27FC236}">
                <a16:creationId xmlns:a16="http://schemas.microsoft.com/office/drawing/2014/main" id="{6695AF0B-C702-474F-99F4-E5FD058C3D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38915" y="3779758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5.1319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2" name="Rectangle 650">
            <a:extLst>
              <a:ext uri="{FF2B5EF4-FFF2-40B4-BE49-F238E27FC236}">
                <a16:creationId xmlns:a16="http://schemas.microsoft.com/office/drawing/2014/main" id="{D83478B7-5086-4937-9796-94B619B55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1488" y="4009503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34.0583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5" name="Rectangle 653">
            <a:extLst>
              <a:ext uri="{FF2B5EF4-FFF2-40B4-BE49-F238E27FC236}">
                <a16:creationId xmlns:a16="http://schemas.microsoft.com/office/drawing/2014/main" id="{9E20FDA7-9701-44F7-9737-E1E5BA7A89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3064" y="4212903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2.0690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8" name="Rectangle 656">
            <a:extLst>
              <a:ext uri="{FF2B5EF4-FFF2-40B4-BE49-F238E27FC236}">
                <a16:creationId xmlns:a16="http://schemas.microsoft.com/office/drawing/2014/main" id="{02C8D079-E7B8-4A1A-BE26-8C009901E6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24597" y="4589205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8.1593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1" name="Rectangle 659">
            <a:extLst>
              <a:ext uri="{FF2B5EF4-FFF2-40B4-BE49-F238E27FC236}">
                <a16:creationId xmlns:a16="http://schemas.microsoft.com/office/drawing/2014/main" id="{847819EF-4E19-474C-8F2E-C5F4E0F5C8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6963" y="4698281"/>
            <a:ext cx="5530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2.0814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8" name="Rectangle 666">
            <a:extLst>
              <a:ext uri="{FF2B5EF4-FFF2-40B4-BE49-F238E27FC236}">
                <a16:creationId xmlns:a16="http://schemas.microsoft.com/office/drawing/2014/main" id="{D7D60D01-804C-4B5B-AB20-C13DBDEEEE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7709" y="4732339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73.1854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64" name="Rectangle 672">
            <a:extLst>
              <a:ext uri="{FF2B5EF4-FFF2-40B4-BE49-F238E27FC236}">
                <a16:creationId xmlns:a16="http://schemas.microsoft.com/office/drawing/2014/main" id="{C5195797-2F7A-4788-8BF0-33CDB0EBC2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1975" y="4720466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7.0973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70" name="Line 678">
            <a:extLst>
              <a:ext uri="{FF2B5EF4-FFF2-40B4-BE49-F238E27FC236}">
                <a16:creationId xmlns:a16="http://schemas.microsoft.com/office/drawing/2014/main" id="{BF787F2F-B668-4356-A099-FFE51E95DD0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50566" y="4980855"/>
            <a:ext cx="17463" cy="11113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4" name="Rectangle 682">
            <a:extLst>
              <a:ext uri="{FF2B5EF4-FFF2-40B4-BE49-F238E27FC236}">
                <a16:creationId xmlns:a16="http://schemas.microsoft.com/office/drawing/2014/main" id="{2597DCB4-4F8E-4C65-9F27-E8DC781CDF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8970" y="4921653"/>
            <a:ext cx="72295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9.10243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80" name="Rectangle 688">
            <a:extLst>
              <a:ext uri="{FF2B5EF4-FFF2-40B4-BE49-F238E27FC236}">
                <a16:creationId xmlns:a16="http://schemas.microsoft.com/office/drawing/2014/main" id="{7F5E2592-36B1-41E6-966B-6C7D73488E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7394" y="4948847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90.1478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97" name="Line 705">
            <a:extLst>
              <a:ext uri="{FF2B5EF4-FFF2-40B4-BE49-F238E27FC236}">
                <a16:creationId xmlns:a16="http://schemas.microsoft.com/office/drawing/2014/main" id="{A6FE85A5-EE9A-44DE-9CBA-0C0995D3462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27966" y="5165005"/>
            <a:ext cx="50800" cy="11113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05" name="Picture 1704">
            <a:extLst>
              <a:ext uri="{FF2B5EF4-FFF2-40B4-BE49-F238E27FC236}">
                <a16:creationId xmlns:a16="http://schemas.microsoft.com/office/drawing/2014/main" id="{A1083CCB-218F-44D4-AF36-670C8EBC28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3366" y="4011792"/>
            <a:ext cx="502236" cy="608771"/>
          </a:xfrm>
          <a:prstGeom prst="rect">
            <a:avLst/>
          </a:prstGeom>
        </p:spPr>
      </p:pic>
      <p:pic>
        <p:nvPicPr>
          <p:cNvPr id="1707" name="Picture 1706">
            <a:extLst>
              <a:ext uri="{FF2B5EF4-FFF2-40B4-BE49-F238E27FC236}">
                <a16:creationId xmlns:a16="http://schemas.microsoft.com/office/drawing/2014/main" id="{9F32FB1B-2C21-463C-9F74-A1608D4FF6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9269" y="4056637"/>
            <a:ext cx="453496" cy="869201"/>
          </a:xfrm>
          <a:prstGeom prst="rect">
            <a:avLst/>
          </a:prstGeom>
        </p:spPr>
      </p:pic>
      <p:pic>
        <p:nvPicPr>
          <p:cNvPr id="1709" name="Picture 1708">
            <a:extLst>
              <a:ext uri="{FF2B5EF4-FFF2-40B4-BE49-F238E27FC236}">
                <a16:creationId xmlns:a16="http://schemas.microsoft.com/office/drawing/2014/main" id="{00EC8842-8CCF-43E1-8678-78FD2FCF04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64923" y="2611146"/>
            <a:ext cx="1622544" cy="821808"/>
          </a:xfrm>
          <a:prstGeom prst="rect">
            <a:avLst/>
          </a:prstGeom>
        </p:spPr>
      </p:pic>
      <p:sp>
        <p:nvSpPr>
          <p:cNvPr id="1710" name="TextBox 1709">
            <a:extLst>
              <a:ext uri="{FF2B5EF4-FFF2-40B4-BE49-F238E27FC236}">
                <a16:creationId xmlns:a16="http://schemas.microsoft.com/office/drawing/2014/main" id="{08CDA28E-C302-4304-872D-AF1BE4942826}"/>
              </a:ext>
            </a:extLst>
          </p:cNvPr>
          <p:cNvSpPr txBox="1"/>
          <p:nvPr/>
        </p:nvSpPr>
        <p:spPr>
          <a:xfrm>
            <a:off x="8026840" y="4186536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H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712" name="Straight Arrow Connector 1711">
            <a:extLst>
              <a:ext uri="{FF2B5EF4-FFF2-40B4-BE49-F238E27FC236}">
                <a16:creationId xmlns:a16="http://schemas.microsoft.com/office/drawing/2014/main" id="{EBED5FC0-B19F-4D14-BE12-1D321DF4688E}"/>
              </a:ext>
            </a:extLst>
          </p:cNvPr>
          <p:cNvCxnSpPr>
            <a:stCxn id="1710" idx="1"/>
          </p:cNvCxnSpPr>
          <p:nvPr/>
        </p:nvCxnSpPr>
        <p:spPr>
          <a:xfrm flipH="1">
            <a:off x="6237288" y="4371202"/>
            <a:ext cx="1789552" cy="263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3" name="TextBox 1712">
            <a:extLst>
              <a:ext uri="{FF2B5EF4-FFF2-40B4-BE49-F238E27FC236}">
                <a16:creationId xmlns:a16="http://schemas.microsoft.com/office/drawing/2014/main" id="{F771CED9-3387-4861-933B-8E87A2EFB365}"/>
              </a:ext>
            </a:extLst>
          </p:cNvPr>
          <p:cNvSpPr txBox="1"/>
          <p:nvPr/>
        </p:nvSpPr>
        <p:spPr>
          <a:xfrm>
            <a:off x="6526123" y="3764250"/>
            <a:ext cx="13596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COOH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CH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H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1715" name="Picture 1714">
            <a:extLst>
              <a:ext uri="{FF2B5EF4-FFF2-40B4-BE49-F238E27FC236}">
                <a16:creationId xmlns:a16="http://schemas.microsoft.com/office/drawing/2014/main" id="{FA646A25-106E-4428-A5B8-53CCBD9357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73724" y="2822935"/>
            <a:ext cx="782751" cy="1136251"/>
          </a:xfrm>
          <a:prstGeom prst="rect">
            <a:avLst/>
          </a:prstGeom>
        </p:spPr>
      </p:pic>
      <p:pic>
        <p:nvPicPr>
          <p:cNvPr id="1717" name="Picture 1716">
            <a:extLst>
              <a:ext uri="{FF2B5EF4-FFF2-40B4-BE49-F238E27FC236}">
                <a16:creationId xmlns:a16="http://schemas.microsoft.com/office/drawing/2014/main" id="{AEB598A3-948B-4A6F-9AE2-06A98268EC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49563" y="3075020"/>
            <a:ext cx="668435" cy="839001"/>
          </a:xfrm>
          <a:prstGeom prst="rect">
            <a:avLst/>
          </a:prstGeom>
        </p:spPr>
      </p:pic>
      <p:pic>
        <p:nvPicPr>
          <p:cNvPr id="1719" name="Picture 1718">
            <a:extLst>
              <a:ext uri="{FF2B5EF4-FFF2-40B4-BE49-F238E27FC236}">
                <a16:creationId xmlns:a16="http://schemas.microsoft.com/office/drawing/2014/main" id="{6033C8C8-A0C3-453D-BEF8-9CB19A12A8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13123" y="2532136"/>
            <a:ext cx="840699" cy="840699"/>
          </a:xfrm>
          <a:prstGeom prst="rect">
            <a:avLst/>
          </a:prstGeom>
        </p:spPr>
      </p:pic>
      <p:cxnSp>
        <p:nvCxnSpPr>
          <p:cNvPr id="1721" name="Straight Arrow Connector 1720">
            <a:extLst>
              <a:ext uri="{FF2B5EF4-FFF2-40B4-BE49-F238E27FC236}">
                <a16:creationId xmlns:a16="http://schemas.microsoft.com/office/drawing/2014/main" id="{EAC10AEA-2F60-4CAC-B1AE-9E04F8C546A4}"/>
              </a:ext>
            </a:extLst>
          </p:cNvPr>
          <p:cNvCxnSpPr/>
          <p:nvPr/>
        </p:nvCxnSpPr>
        <p:spPr>
          <a:xfrm flipH="1" flipV="1">
            <a:off x="2400300" y="3314700"/>
            <a:ext cx="392113" cy="13049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24" name="Picture 1723">
            <a:extLst>
              <a:ext uri="{FF2B5EF4-FFF2-40B4-BE49-F238E27FC236}">
                <a16:creationId xmlns:a16="http://schemas.microsoft.com/office/drawing/2014/main" id="{09A45FC6-15E8-4A98-AE0C-F353B7E59C4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73247" y="2467148"/>
            <a:ext cx="1147062" cy="1380155"/>
          </a:xfrm>
          <a:prstGeom prst="rect">
            <a:avLst/>
          </a:prstGeom>
        </p:spPr>
      </p:pic>
      <p:sp>
        <p:nvSpPr>
          <p:cNvPr id="1725" name="TextBox 1724">
            <a:extLst>
              <a:ext uri="{FF2B5EF4-FFF2-40B4-BE49-F238E27FC236}">
                <a16:creationId xmlns:a16="http://schemas.microsoft.com/office/drawing/2014/main" id="{AAB4E828-0DAD-4BE0-BE35-B146C10DFAEA}"/>
              </a:ext>
            </a:extLst>
          </p:cNvPr>
          <p:cNvSpPr txBox="1"/>
          <p:nvPr/>
        </p:nvSpPr>
        <p:spPr>
          <a:xfrm flipH="1">
            <a:off x="7941012" y="3708803"/>
            <a:ext cx="74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nsy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6" name="TextBox 1725">
            <a:extLst>
              <a:ext uri="{FF2B5EF4-FFF2-40B4-BE49-F238E27FC236}">
                <a16:creationId xmlns:a16="http://schemas.microsoft.com/office/drawing/2014/main" id="{A0BA00E6-7168-4B3D-8A63-604C7C4786BA}"/>
              </a:ext>
            </a:extLst>
          </p:cNvPr>
          <p:cNvSpPr txBox="1"/>
          <p:nvPr/>
        </p:nvSpPr>
        <p:spPr>
          <a:xfrm>
            <a:off x="1488162" y="1247997"/>
            <a:ext cx="6135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S/MS Spectrum of Dansylated N-Acetyl-Ornithine (NAO)</a:t>
            </a:r>
          </a:p>
        </p:txBody>
      </p:sp>
    </p:spTree>
    <p:extLst>
      <p:ext uri="{BB962C8B-B14F-4D97-AF65-F5344CB8AC3E}">
        <p14:creationId xmlns:p14="http://schemas.microsoft.com/office/powerpoint/2010/main" val="280430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re_x002d_Migration_x0020_Date_x0020_Modified xmlns="28efd9a5-36d1-447d-b6ab-9aa3cf4b04aa" xsi:nil="true"/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C90A9DEFCF0047BEEE0A269CDD5246" ma:contentTypeVersion="15" ma:contentTypeDescription="Create a new document." ma:contentTypeScope="" ma:versionID="64a4085b5c7b62ba3872c00eaf7edf8a">
  <xsd:schema xmlns:xsd="http://www.w3.org/2001/XMLSchema" xmlns:xs="http://www.w3.org/2001/XMLSchema" xmlns:p="http://schemas.microsoft.com/office/2006/metadata/properties" xmlns:ns1="http://schemas.microsoft.com/sharepoint/v3" xmlns:ns3="46c218e9-f371-4985-bf81-27f1a9e04205" xmlns:ns4="28efd9a5-36d1-447d-b6ab-9aa3cf4b04aa" targetNamespace="http://schemas.microsoft.com/office/2006/metadata/properties" ma:root="true" ma:fieldsID="9271ac9f2e1ec529685b93cb9039fd18" ns1:_="" ns3:_="" ns4:_="">
    <xsd:import namespace="http://schemas.microsoft.com/sharepoint/v3"/>
    <xsd:import namespace="46c218e9-f371-4985-bf81-27f1a9e04205"/>
    <xsd:import namespace="28efd9a5-36d1-447d-b6ab-9aa3cf4b04a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Pre_x002d_Migration_x0020_Date_x0020_Modified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1:_ip_UnifiedCompliancePolicyProperties" minOccurs="0"/>
                <xsd:element ref="ns1:_ip_UnifiedCompliancePolicyUIAction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c218e9-f371-4985-bf81-27f1a9e0420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fd9a5-36d1-447d-b6ab-9aa3cf4b04a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Pre_x002d_Migration_x0020_Date_x0020_Modified" ma:index="15" nillable="true" ma:displayName="Pre-Migration Date Modified" ma:internalName="Pre_x002d_Migration_x0020_Date_x0020_Modified">
      <xsd:simpleType>
        <xsd:restriction base="dms:DateTim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2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8CE1D7D-6AC9-4FB7-9E9E-D5537A7B22B6}">
  <ds:schemaRefs>
    <ds:schemaRef ds:uri="46c218e9-f371-4985-bf81-27f1a9e04205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sharepoint/v3"/>
    <ds:schemaRef ds:uri="http://purl.org/dc/terms/"/>
    <ds:schemaRef ds:uri="http://schemas.openxmlformats.org/package/2006/metadata/core-properties"/>
    <ds:schemaRef ds:uri="28efd9a5-36d1-447d-b6ab-9aa3cf4b04aa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F3C8134C-1578-479E-8783-268934A8C1E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7C242F3-B0DD-4527-BDE9-DF8451C54A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46c218e9-f371-4985-bf81-27f1a9e04205"/>
    <ds:schemaRef ds:uri="28efd9a5-36d1-447d-b6ab-9aa3cf4b04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02</TotalTime>
  <Words>57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Exactive</dc:creator>
  <cp:lastModifiedBy>Zhang, Kangling</cp:lastModifiedBy>
  <cp:revision>4</cp:revision>
  <dcterms:created xsi:type="dcterms:W3CDTF">2021-10-05T19:33:13Z</dcterms:created>
  <dcterms:modified xsi:type="dcterms:W3CDTF">2022-08-20T22:12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C90A9DEFCF0047BEEE0A269CDD5246</vt:lpwstr>
  </property>
</Properties>
</file>